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00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93" d="100"/>
          <a:sy n="93" d="100"/>
        </p:scale>
        <p:origin x="73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2177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760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8632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03583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5497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0100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3989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908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3655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2869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678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73164F-BFB4-4510-BAD3-7DE8AEBF769F}" type="datetimeFigureOut">
              <a:rPr kumimoji="1" lang="ja-JP" altLang="en-US" smtClean="0"/>
              <a:t>2020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D04B62-5A73-483F-80DA-1C7A13C1E6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395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2099" y="481679"/>
            <a:ext cx="5578153" cy="4681478"/>
          </a:xfrm>
          <a:prstGeom prst="rect">
            <a:avLst/>
          </a:prstGeom>
        </p:spPr>
      </p:pic>
      <p:sp>
        <p:nvSpPr>
          <p:cNvPr id="4" name="正方形/長方形 3"/>
          <p:cNvSpPr/>
          <p:nvPr/>
        </p:nvSpPr>
        <p:spPr>
          <a:xfrm>
            <a:off x="633985" y="5201752"/>
            <a:ext cx="781289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Fig. S1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hylogenetic relationship of KSAP7 and KSAP11 to other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lviaviruses</a:t>
            </a:r>
            <a:r>
              <a:rPr lang="en-US" altLang="ja-JP" sz="12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.</a:t>
            </a:r>
            <a:r>
              <a:rPr lang="ja-JP" altLang="en-US" sz="12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After</a:t>
            </a:r>
            <a:r>
              <a:rPr lang="ja-JP" altLang="en-US" sz="12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the 5’-terminus of  each phage DNA was adjusted to that of </a:t>
            </a:r>
            <a:r>
              <a:rPr lang="en-US" altLang="ja-JP" sz="1200">
                <a:latin typeface="Times New Roman" panose="02020603050405020304" pitchFamily="18" charset="0"/>
                <a:ea typeface="ＭＳ 明朝" panose="02020609040205080304" pitchFamily="17" charset="-128"/>
              </a:rPr>
              <a:t>phage </a:t>
            </a:r>
            <a:r>
              <a:rPr lang="en-US" altLang="ja-JP" sz="120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Romulus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, these DNA sequences were analyzed by NJ method using Mega7. </a:t>
            </a:r>
            <a:endParaRPr lang="ja-JP" altLang="en-US" sz="12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418385" y="6148666"/>
            <a:ext cx="18646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kumimoji="1" lang="en-US" altLang="ja-JP" sz="14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Kitamura</a:t>
            </a:r>
            <a:r>
              <a:rPr lang="ja-JP" alt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279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2</TotalTime>
  <Words>50</Words>
  <Application>Microsoft Office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zaki</dc:creator>
  <cp:lastModifiedBy>Matsuzaki</cp:lastModifiedBy>
  <cp:revision>52</cp:revision>
  <dcterms:created xsi:type="dcterms:W3CDTF">2019-10-02T01:08:57Z</dcterms:created>
  <dcterms:modified xsi:type="dcterms:W3CDTF">2020-06-22T07:59:12Z</dcterms:modified>
</cp:coreProperties>
</file>